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73" r:id="rId1"/>
  </p:sldMasterIdLst>
  <p:notesMasterIdLst>
    <p:notesMasterId r:id="rId9"/>
  </p:notesMasterIdLst>
  <p:handoutMasterIdLst>
    <p:handoutMasterId r:id="rId10"/>
  </p:handoutMasterIdLst>
  <p:sldIdLst>
    <p:sldId id="388" r:id="rId2"/>
    <p:sldId id="534" r:id="rId3"/>
    <p:sldId id="644" r:id="rId4"/>
    <p:sldId id="586" r:id="rId5"/>
    <p:sldId id="687" r:id="rId6"/>
    <p:sldId id="684" r:id="rId7"/>
    <p:sldId id="645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hannon Satterwhite" initials="SS" lastIdx="13" clrIdx="0">
    <p:extLst/>
  </p:cmAuthor>
  <p:cmAuthor id="2" name="Shannon Satterwhite" initials="SS [2]" lastIdx="0" clrIdx="1">
    <p:extLst/>
  </p:cmAuthor>
  <p:cmAuthor id="3" name="Shannon Satterwhite" initials="SS [3]" lastIdx="1" clrIdx="2">
    <p:extLst/>
  </p:cmAuthor>
  <p:cmAuthor id="4" name="Shannon Satterwhite" initials="SS [4]" lastIdx="1" clrIdx="3">
    <p:extLst/>
  </p:cmAuthor>
  <p:cmAuthor id="5" name="Shannon Satterwhite" initials="SS [5]" lastIdx="1" clrIdx="4">
    <p:extLst/>
  </p:cmAuthor>
  <p:cmAuthor id="6" name="Shannon Satterwhite" initials="SS [6]" lastIdx="1" clrIdx="5">
    <p:extLst/>
  </p:cmAuthor>
  <p:cmAuthor id="7" name="Shannon Satterwhite" initials="SS [7]" lastIdx="1" clrIdx="6">
    <p:extLst/>
  </p:cmAuthor>
  <p:cmAuthor id="8" name="Shannon Satterwhite" initials="SS [8]" lastIdx="1" clrIdx="7">
    <p:extLst/>
  </p:cmAuthor>
  <p:cmAuthor id="9" name="Shannon Satterwhite" initials="SS [9]" lastIdx="1" clrIdx="8">
    <p:extLst/>
  </p:cmAuthor>
  <p:cmAuthor id="10" name="Shannon Satterwhite" initials="SS [10]" lastIdx="1" clrIdx="9">
    <p:extLst/>
  </p:cmAuthor>
  <p:cmAuthor id="11" name="Shannon Satterwhite" initials="SS [11]" lastIdx="1" clrIdx="10">
    <p:extLst/>
  </p:cmAuthor>
  <p:cmAuthor id="12" name="Shannon Satterwhite" initials="SS [12]" lastIdx="1" clrIdx="11">
    <p:extLst/>
  </p:cmAuthor>
  <p:cmAuthor id="13" name="Shannon Satterwhite" initials="SS [13]" lastIdx="1" clrIdx="12">
    <p:extLst/>
  </p:cmAuthor>
  <p:cmAuthor id="14" name="Shannon Satterwhite" initials="SS [14]" lastIdx="1" clrIdx="13">
    <p:extLst/>
  </p:cmAuthor>
  <p:cmAuthor id="15" name="Shannon Satterwhite" initials="SS [15]" lastIdx="1" clrIdx="14">
    <p:extLst/>
  </p:cmAuthor>
  <p:cmAuthor id="16" name="Shannon Satterwhite" initials="SS [16]" lastIdx="1" clrIdx="15">
    <p:extLst/>
  </p:cmAuthor>
  <p:cmAuthor id="17" name="Shannon Satterwhite" initials="SS [17]" lastIdx="1" clrIdx="16">
    <p:extLst/>
  </p:cmAuthor>
  <p:cmAuthor id="18" name="Michael Harvey" initials="MH" lastIdx="5" clrIdx="17">
    <p:extLst/>
  </p:cmAuthor>
  <p:cmAuthor id="19" name="Michael Harvey" initials="MH [2]" lastIdx="1" clrIdx="18">
    <p:extLst/>
  </p:cmAuthor>
  <p:cmAuthor id="20" name="Michael Harvey" initials="MH [3]" lastIdx="1" clrIdx="19">
    <p:extLst/>
  </p:cmAuthor>
  <p:cmAuthor id="21" name="Michael Harvey" initials="MH [4]" lastIdx="1" clrIdx="20">
    <p:extLst/>
  </p:cmAuthor>
  <p:cmAuthor id="22" name="Michael Harvey" initials="MH [5]" lastIdx="1" clrIdx="21">
    <p:extLst/>
  </p:cmAuthor>
  <p:cmAuthor id="23" name="Michael Harvey" initials="MH [6]" lastIdx="1" clrIdx="22">
    <p:extLst/>
  </p:cmAuthor>
  <p:cmAuthor id="24" name="Michael Harvey" initials="MH [7]" lastIdx="1" clrIdx="23">
    <p:extLst/>
  </p:cmAuthor>
  <p:cmAuthor id="25" name="Michael Harvey" initials="MH [8]" lastIdx="1" clrIdx="24">
    <p:extLst/>
  </p:cmAuthor>
  <p:cmAuthor id="26" name="Michael Harvey" initials="MH [9]" lastIdx="1" clrIdx="25">
    <p:extLst/>
  </p:cmAuthor>
  <p:cmAuthor id="27" name="Michael Harvey" initials="MH [10]" lastIdx="1" clrIdx="26">
    <p:extLst/>
  </p:cmAuthor>
  <p:cmAuthor id="28" name="Michael Harvey" initials="MH [11]" lastIdx="1" clrIdx="27">
    <p:extLst/>
  </p:cmAuthor>
  <p:cmAuthor id="29" name="Michael Harvey" initials="MH [12]" lastIdx="1" clrIdx="28">
    <p:extLst/>
  </p:cmAuthor>
  <p:cmAuthor id="30" name="Michael Harvey" initials="MH [13]" lastIdx="1" clrIdx="29">
    <p:extLst/>
  </p:cmAuthor>
  <p:cmAuthor id="31" name="Michael Harvey" initials="MH [14]" lastIdx="1" clrIdx="30">
    <p:extLst/>
  </p:cmAuthor>
  <p:cmAuthor id="32" name="Michael Harvey" initials="MH [15]" lastIdx="1" clrIdx="31">
    <p:extLst/>
  </p:cmAuthor>
  <p:cmAuthor id="33" name="Michael Harvey" initials="MH [16]" lastIdx="1" clrIdx="32">
    <p:extLst/>
  </p:cmAuthor>
  <p:cmAuthor id="34" name="Michael Harvey" initials="MH [17]" lastIdx="1" clrIdx="33">
    <p:extLst/>
  </p:cmAuthor>
  <p:cmAuthor id="35" name="Michael Harvey" initials="MH [18]" lastIdx="1" clrIdx="34">
    <p:extLst/>
  </p:cmAuthor>
  <p:cmAuthor id="36" name="Michael Harvey" initials="MH [19]" lastIdx="1" clrIdx="35">
    <p:extLst/>
  </p:cmAuthor>
  <p:cmAuthor id="37" name="Jorge Luis De Avila" initials="JA" lastIdx="4" clrIdx="36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314" autoAdjust="0"/>
    <p:restoredTop sz="83952" autoAdjust="0"/>
  </p:normalViewPr>
  <p:slideViewPr>
    <p:cSldViewPr snapToGrid="0">
      <p:cViewPr varScale="1">
        <p:scale>
          <a:sx n="96" d="100"/>
          <a:sy n="96" d="100"/>
        </p:scale>
        <p:origin x="732" y="8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75" d="100"/>
        <a:sy n="75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050C8849-E25A-044D-8C61-8E0C2CF6D23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543BF4-D5E1-5440-85D6-7998E2C6E5A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1C680B-91B3-F648-AD15-A29C1AEA604D}" type="datetime1">
              <a:rPr lang="en-US" smtClean="0"/>
              <a:pPr/>
              <a:t>3/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6D4A55E-92D0-A149-8D27-B33EF10D069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23FE231-4C29-5041-A953-799EE96E0D7A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A00BF1-2E1D-B843-9BE8-66CEBD69AFA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209055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92978E-541F-8B4A-BE46-3960E1470523}" type="datetime1">
              <a:rPr lang="en-US" smtClean="0"/>
              <a:pPr/>
              <a:t>3/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0DF280-13BC-432D-A00A-95E913C75B6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999485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Shape 95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6" name="Shape 96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 lang="en-US" b="1" baseline="0" dirty="0"/>
          </a:p>
        </p:txBody>
      </p:sp>
      <p:sp>
        <p:nvSpPr>
          <p:cNvPr id="97" name="Shape 97"/>
          <p:cNvSpPr txBox="1">
            <a:spLocks noGrp="1"/>
          </p:cNvSpPr>
          <p:nvPr>
            <p:ph type="sldNum" idx="12"/>
          </p:nvPr>
        </p:nvSpPr>
        <p:spPr>
          <a:xfrm>
            <a:off x="3884612" y="8685213"/>
            <a:ext cx="2971799" cy="457200"/>
          </a:xfrm>
          <a:prstGeom prst="rect">
            <a:avLst/>
          </a:prstGeom>
        </p:spPr>
        <p:txBody>
          <a:bodyPr lIns="91425" tIns="45700" rIns="91425" bIns="45700" anchor="b" anchorCtr="0">
            <a:noAutofit/>
          </a:bodyPr>
          <a:lstStyle/>
          <a:p>
            <a:pPr lvl="0">
              <a:spcBef>
                <a:spcPts val="0"/>
              </a:spcBef>
              <a:buClr>
                <a:srgbClr val="000000"/>
              </a:buClr>
              <a:buSzPct val="25000"/>
              <a:buFont typeface="Arial"/>
              <a:buNone/>
            </a:pPr>
            <a:fld id="{00000000-1234-1234-1234-123412341234}" type="slidenum">
              <a:rPr lang="en-US"/>
              <a:pPr lvl="0">
                <a:spcBef>
                  <a:spcPts val="0"/>
                </a:spcBef>
                <a:buClr>
                  <a:srgbClr val="000000"/>
                </a:buClr>
                <a:buSzPct val="25000"/>
                <a:buFont typeface="Arial"/>
                <a:buNone/>
              </a:pPr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295279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baseline="0" dirty="0"/>
              <a:t>What is the Structural Competency Working Group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DF280-13BC-432D-A00A-95E913C75B6A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73889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Introduce self, role, and relation to field of structural capacity – in what capacity have you worked in this field or in your practice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DF280-13BC-432D-A00A-95E913C75B6A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0064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baseline="0" dirty="0"/>
              <a:t>Learning objectives for the day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DF280-13BC-432D-A00A-95E913C75B6A}" type="slidenum">
              <a:rPr lang="en-US" smtClean="0"/>
              <a:pPr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707615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Take time to establish positionality in your role, recognizing experience with the subject matter, any privileges and possible blind spots, and being open to feedback from audience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0DF280-13BC-432D-A00A-95E913C75B6A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46765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Use this time to verbally establish a general agenda for the day/training.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DF280-13BC-432D-A00A-95E913C75B6A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56895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Establish group agreements for learning and discussion. Ask audience for what they want agreements for the day to b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0DF280-13BC-432D-A00A-95E913C75B6A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4512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C83E5-DD83-4A43-B07D-DFED6E500CA0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/4/2020</a:t>
            </a:fld>
            <a:endParaRPr lang="en-US" dirty="0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pic>
        <p:nvPicPr>
          <p:cNvPr id="8" name="Picture 7" descr="SCWG_image.png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026" y="6093149"/>
            <a:ext cx="1219553" cy="630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6417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9C127-409C-E349-9B77-5121AA8C1DBA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/4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0999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ACC72-E93C-8B41-92FF-99850DBD9DB7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/4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5668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0A8A-A765-EE41-BC5E-70AB85620DB9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/4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36448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81FA0-4E8F-934A-9E13-7CB8034155A7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/4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2297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ED260-4A25-F143-B095-CAC353FB96A1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/4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70673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54BFD-88A9-5443-B537-7A85FA4C3EBB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/4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9603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3A222-B977-7241-8C2B-8408B47BD3DD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/4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36708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8AF5-024C-B642-8E39-9B857702EEEF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/4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5584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5E617-6640-5046-9656-210BD196C9FE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/4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31516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39CC7-F0FC-1548-B166-E21DB12D272C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/4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564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fld id="{BCEB2EAC-856F-F648-A8A0-447321EE4F86}" type="datetime1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457200"/>
              <a:t>3/4/2020</a:t>
            </a:fld>
            <a:endParaRPr lang="en-US" dirty="0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r>
              <a:rPr lang="mr-IN">
                <a:solidFill>
                  <a:prstClr val="black">
                    <a:lumMod val="65000"/>
                    <a:lumOff val="35000"/>
                  </a:prstClr>
                </a:solidFill>
              </a:rPr>
              <a:t>?</a:t>
            </a:r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 defTabSz="457200"/>
              <a:t>‹#›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2336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Shape 99"/>
          <p:cNvSpPr txBox="1"/>
          <p:nvPr>
            <p:extLst/>
          </p:nvPr>
        </p:nvSpPr>
        <p:spPr>
          <a:xfrm>
            <a:off x="743918" y="4610553"/>
            <a:ext cx="10678332" cy="1142058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>
            <a:noAutofit/>
          </a:bodyPr>
          <a:lstStyle/>
          <a:p>
            <a:pPr algn="ctr"/>
            <a:r>
              <a:rPr lang="en-US" sz="4400" dirty="0">
                <a:latin typeface="Calibri Light (Heading)"/>
                <a:ea typeface="Questrial"/>
                <a:cs typeface="Calibri Light (Heading)"/>
                <a:sym typeface="Questrial"/>
              </a:rPr>
              <a:t>Structural Competency Training</a:t>
            </a:r>
          </a:p>
          <a:p>
            <a:pPr algn="ctr"/>
            <a:endParaRPr lang="en-US" sz="2400" dirty="0">
              <a:latin typeface="Century Gothic" panose="020B0502020202020204" pitchFamily="34" charset="0"/>
              <a:ea typeface="Questrial"/>
              <a:cs typeface="Questrial"/>
              <a:sym typeface="Questrial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5DABC2A-2BF7-8249-BD4F-0F01BE2183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31096" y="539998"/>
            <a:ext cx="6903977" cy="35707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2417645"/>
      </p:ext>
    </p:extLst>
  </p:cSld>
  <p:clrMapOvr>
    <a:masterClrMapping/>
  </p:clrMapOvr>
  <p:transition spd="slow">
    <p:cut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  <p:extLst/>
          </p:nvPr>
        </p:nvSpPr>
        <p:spPr>
          <a:xfrm>
            <a:off x="734580" y="449473"/>
            <a:ext cx="10972800" cy="1207655"/>
          </a:xfrm>
        </p:spPr>
        <p:txBody>
          <a:bodyPr/>
          <a:lstStyle/>
          <a:p>
            <a:r>
              <a:rPr lang="en-US" dirty="0">
                <a:latin typeface="Calibri Light"/>
                <a:cs typeface="Calibri Light"/>
              </a:rPr>
              <a:t>Structural Competency Working Group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719" y="2245202"/>
            <a:ext cx="10972800" cy="3876753"/>
          </a:xfrm>
        </p:spPr>
        <p:txBody>
          <a:bodyPr vert="horz" lIns="91440" tIns="45720" rIns="91440" bIns="45720" rtlCol="0" anchor="t">
            <a:normAutofit/>
          </a:bodyPr>
          <a:lstStyle/>
          <a:p>
            <a:pPr marL="457200" lvl="3" indent="0">
              <a:buNone/>
            </a:pPr>
            <a:r>
              <a:rPr lang="en-US" sz="2800" dirty="0">
                <a:latin typeface="Calibri Light"/>
                <a:cs typeface="Calibri Light"/>
              </a:rPr>
              <a:t>Focused on integrating structural competency into training and practice of healthcare providers</a:t>
            </a:r>
          </a:p>
          <a:p>
            <a:pPr marL="914400" lvl="3" indent="-457200">
              <a:buFont typeface="Arial" panose="020B0604020202020204" pitchFamily="34" charset="0"/>
              <a:buChar char="•"/>
            </a:pPr>
            <a:endParaRPr lang="en-US" sz="2800" dirty="0">
              <a:latin typeface="Calibri Light"/>
              <a:cs typeface="Calibri Light"/>
            </a:endParaRPr>
          </a:p>
          <a:p>
            <a:pPr marL="457200" lvl="3" indent="0">
              <a:buNone/>
            </a:pPr>
            <a:r>
              <a:rPr lang="en-US" sz="2800" dirty="0">
                <a:latin typeface="Calibri Light"/>
                <a:cs typeface="Calibri Light"/>
              </a:rPr>
              <a:t>Comprised of nurses, physicians, scholars in the medical social sciences, health administrators, community health activists, and graduate and professional students in several disciplines</a:t>
            </a:r>
          </a:p>
        </p:txBody>
      </p:sp>
      <p:sp>
        <p:nvSpPr>
          <p:cNvPr id="4" name="AutoShape 2" descr="Image result for sella turcica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mc="http://schemas.openxmlformats.org/markup-compatibility/2006" xmlns:mv="urn:schemas-microsoft-com:mac:vml"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pic>
        <p:nvPicPr>
          <p:cNvPr id="14" name="Picture 13" descr="SCWG_imag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500" y="5961405"/>
            <a:ext cx="1395927" cy="72197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9F022F-F308-544F-9ECD-A36E8EC3C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2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3811930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95133" y="2414059"/>
            <a:ext cx="5647267" cy="1325563"/>
          </a:xfrm>
        </p:spPr>
        <p:txBody>
          <a:bodyPr/>
          <a:lstStyle/>
          <a:p>
            <a:r>
              <a:rPr lang="en-US" dirty="0"/>
              <a:t>Facilitator Introductions</a:t>
            </a:r>
          </a:p>
        </p:txBody>
      </p:sp>
      <p:pic>
        <p:nvPicPr>
          <p:cNvPr id="7" name="Picture 6" descr="SCWG_imag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500" y="5961405"/>
            <a:ext cx="1395927" cy="721970"/>
          </a:xfrm>
          <a:prstGeom prst="rect">
            <a:avLst/>
          </a:prstGeo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8E08FB-C6A6-CB45-A110-61113EF2E5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3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902958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>
            <a:spLocks noGrp="1"/>
          </p:cNvSpPr>
          <p:nvPr>
            <p:ph type="title"/>
            <p:extLst/>
          </p:nvPr>
        </p:nvSpPr>
        <p:spPr>
          <a:xfrm>
            <a:off x="642216" y="426383"/>
            <a:ext cx="10972800" cy="1600200"/>
          </a:xfrm>
        </p:spPr>
        <p:txBody>
          <a:bodyPr/>
          <a:lstStyle/>
          <a:p>
            <a:r>
              <a:rPr lang="en-US" dirty="0">
                <a:latin typeface="Calibri Light"/>
                <a:cs typeface="Calibri Light"/>
              </a:rPr>
              <a:t>Structural Competency Sess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9379" y="1946739"/>
            <a:ext cx="11065637" cy="3699566"/>
          </a:xfrm>
        </p:spPr>
        <p:txBody>
          <a:bodyPr vert="horz" lIns="91440" tIns="45720" rIns="91440" bIns="45720" rtlCol="0" anchor="t">
            <a:normAutofit lnSpcReduction="10000"/>
          </a:bodyPr>
          <a:lstStyle/>
          <a:p>
            <a:pPr marL="0" lvl="2" indent="0">
              <a:buNone/>
            </a:pPr>
            <a:r>
              <a:rPr lang="en-US" sz="2800" dirty="0">
                <a:latin typeface="Calibri Light"/>
                <a:cs typeface="Calibri Light"/>
              </a:rPr>
              <a:t>Learning Objectives:</a:t>
            </a:r>
          </a:p>
          <a:p>
            <a:pPr marL="457200" lvl="2" indent="-457200">
              <a:buFont typeface="+mj-lt"/>
              <a:buAutoNum type="arabicPeriod"/>
            </a:pPr>
            <a:r>
              <a:rPr lang="en-US" sz="2800" dirty="0">
                <a:latin typeface="Calibri Light"/>
                <a:cs typeface="Calibri Light"/>
              </a:rPr>
              <a:t>Identify the influences of structures on patient health</a:t>
            </a:r>
          </a:p>
          <a:p>
            <a:pPr marL="457200" lvl="2" indent="-457200">
              <a:buFont typeface="+mj-lt"/>
              <a:buAutoNum type="arabicPeriod"/>
            </a:pPr>
            <a:r>
              <a:rPr lang="en-US" sz="2800" dirty="0">
                <a:latin typeface="Calibri Light"/>
                <a:cs typeface="Calibri Light"/>
              </a:rPr>
              <a:t>Identify the influences of structures on the practice of healthcare</a:t>
            </a:r>
          </a:p>
          <a:p>
            <a:pPr marL="457200" lvl="2" indent="-457200">
              <a:buFont typeface="+mj-lt"/>
              <a:buAutoNum type="arabicPeriod"/>
            </a:pPr>
            <a:r>
              <a:rPr lang="en-US" sz="2800" dirty="0">
                <a:latin typeface="Calibri Light"/>
                <a:cs typeface="Calibri Light"/>
              </a:rPr>
              <a:t>Generate strategies to respond to the influences of structures in the clinic</a:t>
            </a:r>
          </a:p>
          <a:p>
            <a:pPr marL="457200" lvl="2" indent="-457200">
              <a:buFont typeface="+mj-lt"/>
              <a:buAutoNum type="arabicPeriod"/>
            </a:pPr>
            <a:r>
              <a:rPr lang="en-US" sz="2800" dirty="0">
                <a:latin typeface="Calibri Light"/>
                <a:cs typeface="Calibri Light"/>
              </a:rPr>
              <a:t>Generate strategies to respond to the influences of structures beyond the clinic</a:t>
            </a:r>
          </a:p>
          <a:p>
            <a:pPr marL="457200" lvl="2" indent="-457200">
              <a:buFont typeface="+mj-lt"/>
              <a:buAutoNum type="arabicPeriod"/>
            </a:pPr>
            <a:r>
              <a:rPr lang="en-US" sz="2800" dirty="0">
                <a:latin typeface="Calibri Light"/>
                <a:cs typeface="Calibri Light"/>
              </a:rPr>
              <a:t>Describe structural humility as an approach to apply in and beyond the clinic</a:t>
            </a:r>
          </a:p>
          <a:p>
            <a:pPr marL="0" lvl="2" indent="0">
              <a:buNone/>
            </a:pPr>
            <a:endParaRPr lang="en-US" sz="2800" dirty="0">
              <a:latin typeface="Calibri Light"/>
              <a:cs typeface="Calibri Light"/>
            </a:endParaRPr>
          </a:p>
        </p:txBody>
      </p:sp>
      <p:sp>
        <p:nvSpPr>
          <p:cNvPr id="4" name="AutoShape 2" descr="Image result for sella turcica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mc="http://schemas.openxmlformats.org/markup-compatibility/2006" xmlns:mv="urn:schemas-microsoft-com:mac:vml"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pic>
        <p:nvPicPr>
          <p:cNvPr id="8" name="Picture 7" descr="SCWG_imag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500" y="5961405"/>
            <a:ext cx="1395927" cy="721970"/>
          </a:xfrm>
          <a:prstGeom prst="rect">
            <a:avLst/>
          </a:prstGeom>
        </p:spPr>
      </p:pic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6A396E8C-964E-DB44-90FD-3C72C2D74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4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226803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cs typeface="Calibri Light"/>
              </a:rPr>
              <a:t>Structural Competency Session</a:t>
            </a:r>
            <a:endParaRPr lang="en-US" dirty="0">
              <a:latin typeface="Calibri Light "/>
              <a:cs typeface="Calibri Light 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>
                <a:latin typeface="Calibri Light"/>
                <a:cs typeface="Calibri Light"/>
              </a:rPr>
              <a:t>Positionality</a:t>
            </a:r>
            <a:br>
              <a:rPr lang="en-US" dirty="0">
                <a:latin typeface="Calibri Light"/>
                <a:cs typeface="Calibri Light"/>
              </a:rPr>
            </a:br>
            <a:endParaRPr lang="en-US" dirty="0">
              <a:latin typeface="Calibri Light"/>
              <a:cs typeface="Calibri Light"/>
            </a:endParaRPr>
          </a:p>
          <a:p>
            <a:r>
              <a:rPr lang="en-US" dirty="0">
                <a:latin typeface="Calibri Light"/>
                <a:cs typeface="Calibri Light"/>
              </a:rPr>
              <a:t>Not experts</a:t>
            </a:r>
            <a:br>
              <a:rPr lang="en-US" dirty="0">
                <a:latin typeface="Calibri Light"/>
                <a:cs typeface="Calibri Light"/>
              </a:rPr>
            </a:br>
            <a:endParaRPr lang="en-US" dirty="0">
              <a:latin typeface="Calibri Light"/>
              <a:cs typeface="Calibri Light"/>
            </a:endParaRPr>
          </a:p>
          <a:p>
            <a:r>
              <a:rPr lang="en-US" dirty="0">
                <a:latin typeface="Calibri Light"/>
                <a:cs typeface="Calibri Light"/>
              </a:rPr>
              <a:t>Privilege &amp; blind spots</a:t>
            </a:r>
            <a:br>
              <a:rPr lang="en-US" dirty="0">
                <a:latin typeface="Calibri Light"/>
                <a:cs typeface="Calibri Light"/>
              </a:rPr>
            </a:br>
            <a:endParaRPr lang="en-US" dirty="0">
              <a:latin typeface="Calibri Light"/>
              <a:cs typeface="Calibri Light"/>
            </a:endParaRPr>
          </a:p>
          <a:p>
            <a:r>
              <a:rPr lang="en-US" dirty="0">
                <a:latin typeface="Calibri Light"/>
                <a:cs typeface="Calibri Light"/>
              </a:rPr>
              <a:t>Feedback</a:t>
            </a:r>
          </a:p>
        </p:txBody>
      </p:sp>
      <p:pic>
        <p:nvPicPr>
          <p:cNvPr id="4" name="Picture 3" descr="SCWG_imag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3206" y="5959544"/>
            <a:ext cx="1395927" cy="72197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40146BF-4B0D-2A49-B085-218602125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5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63553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DCEBA-AB81-41A0-8BCB-D18BC70FE8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aining Agenda</a:t>
            </a:r>
          </a:p>
        </p:txBody>
      </p:sp>
      <p:pic>
        <p:nvPicPr>
          <p:cNvPr id="7" name="Picture 6" descr="SCWG_imag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500" y="5961405"/>
            <a:ext cx="1395927" cy="721970"/>
          </a:xfrm>
          <a:prstGeom prst="rect">
            <a:avLst/>
          </a:prstGeo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335D31-7E51-A348-AC7E-43BAC133D2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6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01457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21427" y="2408048"/>
            <a:ext cx="7420512" cy="1325563"/>
          </a:xfrm>
        </p:spPr>
        <p:txBody>
          <a:bodyPr>
            <a:noAutofit/>
          </a:bodyPr>
          <a:lstStyle/>
          <a:p>
            <a:pPr algn="ctr"/>
            <a:r>
              <a:rPr lang="en-US" dirty="0"/>
              <a:t>Group Agreements</a:t>
            </a:r>
          </a:p>
        </p:txBody>
      </p:sp>
      <p:pic>
        <p:nvPicPr>
          <p:cNvPr id="7" name="Picture 6" descr="SCWG_imag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500" y="5961405"/>
            <a:ext cx="1395927" cy="72197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AE37870-B950-A14C-8F2B-070AB7E13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1970A-8504-D242-BBEE-B907BAE0C70B}" type="slidenum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7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542943" y="4201634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616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540</TotalTime>
  <Words>239</Words>
  <Application>Microsoft Office PowerPoint</Application>
  <PresentationFormat>Widescreen</PresentationFormat>
  <Paragraphs>39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6" baseType="lpstr">
      <vt:lpstr>Arial</vt:lpstr>
      <vt:lpstr>Calibri</vt:lpstr>
      <vt:lpstr>Calibri Light</vt:lpstr>
      <vt:lpstr>Calibri Light </vt:lpstr>
      <vt:lpstr>Calibri Light (Heading)</vt:lpstr>
      <vt:lpstr>Century Gothic</vt:lpstr>
      <vt:lpstr>Mangal</vt:lpstr>
      <vt:lpstr>Questrial</vt:lpstr>
      <vt:lpstr>Office Theme</vt:lpstr>
      <vt:lpstr>PowerPoint Presentation</vt:lpstr>
      <vt:lpstr>Structural Competency Working Group</vt:lpstr>
      <vt:lpstr>Facilitator Introductions</vt:lpstr>
      <vt:lpstr>Structural Competency Session</vt:lpstr>
      <vt:lpstr>Structural Competency Session</vt:lpstr>
      <vt:lpstr>Training Agenda</vt:lpstr>
      <vt:lpstr>Group Agreement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h Neff</dc:creator>
  <cp:lastModifiedBy>Charles Rhoads</cp:lastModifiedBy>
  <cp:revision>784</cp:revision>
  <cp:lastPrinted>2018-04-11T20:47:28Z</cp:lastPrinted>
  <dcterms:created xsi:type="dcterms:W3CDTF">2019-05-15T03:46:35Z</dcterms:created>
  <dcterms:modified xsi:type="dcterms:W3CDTF">2020-03-04T15:42:47Z</dcterms:modified>
</cp:coreProperties>
</file>